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BB924A-699A-4F52-BC66-3DEDB728E1B0}" v="1" dt="2024-04-11T15:35:59.44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varajan,Eswaran" userId="aad2c616-30ee-4e19-a463-6aea41bf38a4" providerId="ADAL" clId="{6FBB924A-699A-4F52-BC66-3DEDB728E1B0}"/>
    <pc:docChg chg="modSld">
      <pc:chgData name="Devarajan,Eswaran" userId="aad2c616-30ee-4e19-a463-6aea41bf38a4" providerId="ADAL" clId="{6FBB924A-699A-4F52-BC66-3DEDB728E1B0}" dt="2024-04-11T15:36:42.326" v="11" actId="1076"/>
      <pc:docMkLst>
        <pc:docMk/>
      </pc:docMkLst>
      <pc:sldChg chg="addSp modSp mod">
        <pc:chgData name="Devarajan,Eswaran" userId="aad2c616-30ee-4e19-a463-6aea41bf38a4" providerId="ADAL" clId="{6FBB924A-699A-4F52-BC66-3DEDB728E1B0}" dt="2024-04-11T15:36:42.326" v="11" actId="1076"/>
        <pc:sldMkLst>
          <pc:docMk/>
          <pc:sldMk cId="0" sldId="257"/>
        </pc:sldMkLst>
        <pc:spChg chg="add mod">
          <ac:chgData name="Devarajan,Eswaran" userId="aad2c616-30ee-4e19-a463-6aea41bf38a4" providerId="ADAL" clId="{6FBB924A-699A-4F52-BC66-3DEDB728E1B0}" dt="2024-04-11T15:36:42.326" v="11" actId="1076"/>
          <ac:spMkLst>
            <pc:docMk/>
            <pc:sldMk cId="0" sldId="257"/>
            <ac:spMk id="141" creationId="{8F346B5D-7D5C-056D-A13F-164A0D04B68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82ED8-32D4-4992-A39F-4951BC08FB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4BFA22-E7CB-4576-B826-67FD2C8279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9D2B11-48F6-4684-8114-D58B8A8CB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18F218-3318-447E-A507-AB8794E85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26D4EE-94CA-4CC8-850E-C82027E33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580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23817D-A8CE-4119-8BC3-879B469D9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300026-D2B7-43FE-AD28-BDD0D07607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C325EE-C3F4-4987-B1CD-63FBD2810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F72171-AD6D-4403-8A2F-DDD1B1FE2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C5E44D-E4DD-42DF-8A12-AFF388738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182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436AAF-54DD-4985-B213-B8B0E1F402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01497B-708B-4E68-A1E7-2244F8249E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A332AD-BDCF-4762-A4F2-EDE7D7D07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EE46CE-00CC-4879-9795-30F987686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39A8AD-8E77-4F93-856D-80E79BD23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650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21586D-05F4-49A3-887C-63105BEE62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0E3417-2196-47BE-9B87-CFEEAD7541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C68F00-CF58-4874-9B31-BC5D96116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C0B6D3-8BF6-4404-BB7F-5E2047108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617792-2A8E-4710-AE82-FA4276BC4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824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B0C880-E6CD-4EF8-ACF1-EAEA6CDBA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C80FB2-893C-42E0-8430-7575EE3270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57CB1-613E-4736-9C83-A4F64CBE5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40BEC4-6109-46AF-9449-E2735097A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9EC548-6A7A-4A30-A5CC-B91FE8121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932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2BC432-73CA-45F6-8687-F665E28E24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C04F6D-3C13-404B-B6E7-984B645865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801C4E-0F11-4C29-9644-DCF8ACB7D7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645A85-387F-4818-B13B-E418AD7D6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DA5281-5FB9-466E-BC59-E58BE090C1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643839-CD6A-4531-9E75-77C6FEE0C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066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B33A79-F49C-4681-9439-1008903561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206DFF-EA59-480F-A3EC-2F8C41988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DA692E-6C6C-4834-9DCD-340BAF22E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78094C3-0C4C-4A32-B63D-492BD63094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54430BB-6BCD-47E0-976A-FAD98831BD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F638AF-D6AD-4A79-9512-0BF09DD4F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4B715B-AD7B-442F-B490-A82E68D44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17D664-1C8E-4DB6-9066-FBB83B4F5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123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59E2BA-AD3B-42F4-A8DB-BD71F677A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7B0116-CFAE-42BC-BB6A-A5BD4474D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EA3C63-01D1-4911-B4C9-AA24DAE93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F1E58B-D5C1-4C76-831C-CCE1D4609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447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209CE1-F7F6-440E-B97E-2617E641F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CE8D22A-FB80-45E4-A4CE-DB4462267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8FBD08-205B-4A3B-BD84-AA800E884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373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2B1720-3C6C-473A-A22B-474CA837BF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DCC51-E017-4D45-9634-02C99F7B2F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E66732-5691-4EE2-B84A-D05E00C166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4D536C-BB13-4ED3-8315-16E71EA67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7A5971-C8C1-4280-A2C3-FB379EEE0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27D06F-DA29-4C3A-BCFC-26DA8050D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286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D99616-67E4-430D-9193-A5BDD93E4D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69DD34-0E3C-48AC-B89E-372F66BD14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BE547B-4C77-47B6-A3D8-5678032704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BB321D-4B94-4043-AAEE-FB03CF6F1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7B4032-5916-4A09-A407-21420A7E7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A83078-1A73-4C36-A303-18B721CD3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765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ED9AF02-9D77-4787-8725-8338C4577B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D44C96-A799-472A-BC20-BCDFB55D05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BD5C72-9DA8-4929-9073-ED584F4B4E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4CC50-082B-42E8-AA27-EE56BA1D365A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88B37-880F-41EC-9D99-FD11801288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8F0399-CF63-4F65-A67D-05116AB58E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E504E7-34EF-43A9-9B90-CD14FCD53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486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589657" y="5054727"/>
            <a:ext cx="7611109" cy="0"/>
          </a:xfrm>
          <a:custGeom>
            <a:avLst/>
            <a:gdLst/>
            <a:ahLst/>
            <a:cxnLst/>
            <a:rect l="l" t="t" r="r" b="b"/>
            <a:pathLst>
              <a:path w="7611109">
                <a:moveTo>
                  <a:pt x="0" y="0"/>
                </a:moveTo>
                <a:lnTo>
                  <a:pt x="7610856" y="0"/>
                </a:lnTo>
              </a:path>
            </a:pathLst>
          </a:custGeom>
          <a:ln w="9906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589657" y="4700396"/>
            <a:ext cx="7611109" cy="0"/>
          </a:xfrm>
          <a:custGeom>
            <a:avLst/>
            <a:gdLst/>
            <a:ahLst/>
            <a:cxnLst/>
            <a:rect l="l" t="t" r="r" b="b"/>
            <a:pathLst>
              <a:path w="7611109">
                <a:moveTo>
                  <a:pt x="0" y="0"/>
                </a:moveTo>
                <a:lnTo>
                  <a:pt x="7610856" y="0"/>
                </a:lnTo>
              </a:path>
            </a:pathLst>
          </a:custGeom>
          <a:ln w="9906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2589657" y="4345304"/>
            <a:ext cx="1235075" cy="0"/>
          </a:xfrm>
          <a:custGeom>
            <a:avLst/>
            <a:gdLst/>
            <a:ahLst/>
            <a:cxnLst/>
            <a:rect l="l" t="t" r="r" b="b"/>
            <a:pathLst>
              <a:path w="1235075">
                <a:moveTo>
                  <a:pt x="0" y="0"/>
                </a:moveTo>
                <a:lnTo>
                  <a:pt x="1234820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3909821" y="4345304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4290821" y="4345304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4671059" y="4345304"/>
            <a:ext cx="5529580" cy="0"/>
          </a:xfrm>
          <a:custGeom>
            <a:avLst/>
            <a:gdLst/>
            <a:ahLst/>
            <a:cxnLst/>
            <a:rect l="l" t="t" r="r" b="b"/>
            <a:pathLst>
              <a:path w="5529580">
                <a:moveTo>
                  <a:pt x="0" y="0"/>
                </a:moveTo>
                <a:lnTo>
                  <a:pt x="5529452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2589657" y="3990975"/>
            <a:ext cx="1235075" cy="0"/>
          </a:xfrm>
          <a:custGeom>
            <a:avLst/>
            <a:gdLst/>
            <a:ahLst/>
            <a:cxnLst/>
            <a:rect l="l" t="t" r="r" b="b"/>
            <a:pathLst>
              <a:path w="1235075">
                <a:moveTo>
                  <a:pt x="0" y="0"/>
                </a:moveTo>
                <a:lnTo>
                  <a:pt x="1234820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3909821" y="399097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4290821" y="399097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4671059" y="3990975"/>
            <a:ext cx="1164590" cy="0"/>
          </a:xfrm>
          <a:custGeom>
            <a:avLst/>
            <a:gdLst/>
            <a:ahLst/>
            <a:cxnLst/>
            <a:rect l="l" t="t" r="r" b="b"/>
            <a:pathLst>
              <a:path w="1164589">
                <a:moveTo>
                  <a:pt x="0" y="0"/>
                </a:moveTo>
                <a:lnTo>
                  <a:pt x="1164336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5920740" y="3990975"/>
            <a:ext cx="1817370" cy="0"/>
          </a:xfrm>
          <a:custGeom>
            <a:avLst/>
            <a:gdLst/>
            <a:ahLst/>
            <a:cxnLst/>
            <a:rect l="l" t="t" r="r" b="b"/>
            <a:pathLst>
              <a:path w="1817370">
                <a:moveTo>
                  <a:pt x="0" y="0"/>
                </a:moveTo>
                <a:lnTo>
                  <a:pt x="1817369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823454" y="3990975"/>
            <a:ext cx="676275" cy="0"/>
          </a:xfrm>
          <a:custGeom>
            <a:avLst/>
            <a:gdLst/>
            <a:ahLst/>
            <a:cxnLst/>
            <a:rect l="l" t="t" r="r" b="b"/>
            <a:pathLst>
              <a:path w="676275">
                <a:moveTo>
                  <a:pt x="0" y="0"/>
                </a:moveTo>
                <a:lnTo>
                  <a:pt x="675894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8584692" y="399097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8964930" y="399097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9345930" y="3990975"/>
            <a:ext cx="676275" cy="0"/>
          </a:xfrm>
          <a:custGeom>
            <a:avLst/>
            <a:gdLst/>
            <a:ahLst/>
            <a:cxnLst/>
            <a:rect l="l" t="t" r="r" b="b"/>
            <a:pathLst>
              <a:path w="676275">
                <a:moveTo>
                  <a:pt x="0" y="0"/>
                </a:moveTo>
                <a:lnTo>
                  <a:pt x="675894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10107168" y="3990975"/>
            <a:ext cx="93345" cy="0"/>
          </a:xfrm>
          <a:custGeom>
            <a:avLst/>
            <a:gdLst/>
            <a:ahLst/>
            <a:cxnLst/>
            <a:rect l="l" t="t" r="r" b="b"/>
            <a:pathLst>
              <a:path w="93345">
                <a:moveTo>
                  <a:pt x="0" y="0"/>
                </a:moveTo>
                <a:lnTo>
                  <a:pt x="93344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2589657" y="3635883"/>
            <a:ext cx="1235075" cy="0"/>
          </a:xfrm>
          <a:custGeom>
            <a:avLst/>
            <a:gdLst/>
            <a:ahLst/>
            <a:cxnLst/>
            <a:rect l="l" t="t" r="r" b="b"/>
            <a:pathLst>
              <a:path w="1235075">
                <a:moveTo>
                  <a:pt x="0" y="0"/>
                </a:moveTo>
                <a:lnTo>
                  <a:pt x="1234820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3909821" y="3635883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4290821" y="3635883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4671059" y="3635883"/>
            <a:ext cx="403860" cy="0"/>
          </a:xfrm>
          <a:custGeom>
            <a:avLst/>
            <a:gdLst/>
            <a:ahLst/>
            <a:cxnLst/>
            <a:rect l="l" t="t" r="r" b="b"/>
            <a:pathLst>
              <a:path w="403860">
                <a:moveTo>
                  <a:pt x="0" y="0"/>
                </a:moveTo>
                <a:lnTo>
                  <a:pt x="403860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5540502" y="3635883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5920740" y="3635883"/>
            <a:ext cx="1437640" cy="0"/>
          </a:xfrm>
          <a:custGeom>
            <a:avLst/>
            <a:gdLst/>
            <a:ahLst/>
            <a:cxnLst/>
            <a:rect l="l" t="t" r="r" b="b"/>
            <a:pathLst>
              <a:path w="1437640">
                <a:moveTo>
                  <a:pt x="0" y="0"/>
                </a:moveTo>
                <a:lnTo>
                  <a:pt x="1437131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5160264" y="3635883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7443216" y="3635883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7823454" y="3635883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8204454" y="3635883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8584692" y="3635883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8964930" y="3635883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/>
          <p:nvPr/>
        </p:nvSpPr>
        <p:spPr>
          <a:xfrm>
            <a:off x="9345930" y="3635883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object 31"/>
          <p:cNvSpPr/>
          <p:nvPr/>
        </p:nvSpPr>
        <p:spPr>
          <a:xfrm>
            <a:off x="9726168" y="3635883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object 32"/>
          <p:cNvSpPr/>
          <p:nvPr/>
        </p:nvSpPr>
        <p:spPr>
          <a:xfrm>
            <a:off x="10107168" y="3635883"/>
            <a:ext cx="93345" cy="0"/>
          </a:xfrm>
          <a:custGeom>
            <a:avLst/>
            <a:gdLst/>
            <a:ahLst/>
            <a:cxnLst/>
            <a:rect l="l" t="t" r="r" b="b"/>
            <a:pathLst>
              <a:path w="93345">
                <a:moveTo>
                  <a:pt x="0" y="0"/>
                </a:moveTo>
                <a:lnTo>
                  <a:pt x="93344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object 33"/>
          <p:cNvSpPr/>
          <p:nvPr/>
        </p:nvSpPr>
        <p:spPr>
          <a:xfrm>
            <a:off x="3637788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object 34"/>
          <p:cNvSpPr/>
          <p:nvPr/>
        </p:nvSpPr>
        <p:spPr>
          <a:xfrm>
            <a:off x="3529584" y="3283839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object 35"/>
          <p:cNvSpPr/>
          <p:nvPr/>
        </p:nvSpPr>
        <p:spPr>
          <a:xfrm>
            <a:off x="3909821" y="3283839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" name="object 36"/>
          <p:cNvSpPr/>
          <p:nvPr/>
        </p:nvSpPr>
        <p:spPr>
          <a:xfrm>
            <a:off x="4018026" y="327888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4290821" y="3283839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3148583" y="3278885"/>
            <a:ext cx="403860" cy="0"/>
          </a:xfrm>
          <a:custGeom>
            <a:avLst/>
            <a:gdLst/>
            <a:ahLst/>
            <a:cxnLst/>
            <a:rect l="l" t="t" r="r" b="b"/>
            <a:pathLst>
              <a:path w="403860">
                <a:moveTo>
                  <a:pt x="0" y="0"/>
                </a:moveTo>
                <a:lnTo>
                  <a:pt x="403860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2876550" y="3283839"/>
            <a:ext cx="567690" cy="0"/>
          </a:xfrm>
          <a:custGeom>
            <a:avLst/>
            <a:gdLst/>
            <a:ahLst/>
            <a:cxnLst/>
            <a:rect l="l" t="t" r="r" b="b"/>
            <a:pathLst>
              <a:path w="567689">
                <a:moveTo>
                  <a:pt x="0" y="0"/>
                </a:moveTo>
                <a:lnTo>
                  <a:pt x="567689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4399026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4671059" y="3283839"/>
            <a:ext cx="403860" cy="0"/>
          </a:xfrm>
          <a:custGeom>
            <a:avLst/>
            <a:gdLst/>
            <a:ahLst/>
            <a:cxnLst/>
            <a:rect l="l" t="t" r="r" b="b"/>
            <a:pathLst>
              <a:path w="403860">
                <a:moveTo>
                  <a:pt x="0" y="0"/>
                </a:moveTo>
                <a:lnTo>
                  <a:pt x="403860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2589657" y="3278885"/>
            <a:ext cx="473709" cy="0"/>
          </a:xfrm>
          <a:custGeom>
            <a:avLst/>
            <a:gdLst/>
            <a:ahLst/>
            <a:cxnLst/>
            <a:rect l="l" t="t" r="r" b="b"/>
            <a:pathLst>
              <a:path w="473710">
                <a:moveTo>
                  <a:pt x="0" y="0"/>
                </a:moveTo>
                <a:lnTo>
                  <a:pt x="473582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2589657" y="3283839"/>
            <a:ext cx="201930" cy="0"/>
          </a:xfrm>
          <a:custGeom>
            <a:avLst/>
            <a:gdLst/>
            <a:ahLst/>
            <a:cxnLst/>
            <a:rect l="l" t="t" r="r" b="b"/>
            <a:pathLst>
              <a:path w="201930">
                <a:moveTo>
                  <a:pt x="0" y="0"/>
                </a:moveTo>
                <a:lnTo>
                  <a:pt x="201549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5812535" y="327888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5540502" y="3283839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5920740" y="3283839"/>
            <a:ext cx="1057275" cy="0"/>
          </a:xfrm>
          <a:custGeom>
            <a:avLst/>
            <a:gdLst/>
            <a:ahLst/>
            <a:cxnLst/>
            <a:rect l="l" t="t" r="r" b="b"/>
            <a:pathLst>
              <a:path w="1057275">
                <a:moveTo>
                  <a:pt x="0" y="0"/>
                </a:moveTo>
                <a:lnTo>
                  <a:pt x="1056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object 47"/>
          <p:cNvSpPr/>
          <p:nvPr/>
        </p:nvSpPr>
        <p:spPr>
          <a:xfrm>
            <a:off x="5051297" y="327888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object 48"/>
          <p:cNvSpPr/>
          <p:nvPr/>
        </p:nvSpPr>
        <p:spPr>
          <a:xfrm>
            <a:off x="5160264" y="3283839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" name="object 49"/>
          <p:cNvSpPr/>
          <p:nvPr/>
        </p:nvSpPr>
        <p:spPr>
          <a:xfrm>
            <a:off x="4779264" y="3278885"/>
            <a:ext cx="186690" cy="0"/>
          </a:xfrm>
          <a:custGeom>
            <a:avLst/>
            <a:gdLst/>
            <a:ahLst/>
            <a:cxnLst/>
            <a:rect l="l" t="t" r="r" b="b"/>
            <a:pathLst>
              <a:path w="186689">
                <a:moveTo>
                  <a:pt x="0" y="0"/>
                </a:moveTo>
                <a:lnTo>
                  <a:pt x="186689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object 50"/>
          <p:cNvSpPr/>
          <p:nvPr/>
        </p:nvSpPr>
        <p:spPr>
          <a:xfrm>
            <a:off x="7715250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object 51"/>
          <p:cNvSpPr/>
          <p:nvPr/>
        </p:nvSpPr>
        <p:spPr>
          <a:xfrm>
            <a:off x="7443216" y="3283839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7823454" y="3283839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5432297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7335011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7062216" y="3283839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6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6193535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6954011" y="327888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8476488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8204454" y="3283839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8584692" y="3283839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8095488" y="327888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6573773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" name="object 63"/>
          <p:cNvSpPr/>
          <p:nvPr/>
        </p:nvSpPr>
        <p:spPr>
          <a:xfrm>
            <a:off x="8856726" y="327888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" name="object 64"/>
          <p:cNvSpPr/>
          <p:nvPr/>
        </p:nvSpPr>
        <p:spPr>
          <a:xfrm>
            <a:off x="8964930" y="3283839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" name="object 65"/>
          <p:cNvSpPr/>
          <p:nvPr/>
        </p:nvSpPr>
        <p:spPr>
          <a:xfrm>
            <a:off x="9237726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" name="object 66"/>
          <p:cNvSpPr/>
          <p:nvPr/>
        </p:nvSpPr>
        <p:spPr>
          <a:xfrm>
            <a:off x="9345930" y="3283839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" name="object 67"/>
          <p:cNvSpPr/>
          <p:nvPr/>
        </p:nvSpPr>
        <p:spPr>
          <a:xfrm>
            <a:off x="9617964" y="327888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" name="object 68"/>
          <p:cNvSpPr/>
          <p:nvPr/>
        </p:nvSpPr>
        <p:spPr>
          <a:xfrm>
            <a:off x="9998202" y="3278885"/>
            <a:ext cx="202565" cy="0"/>
          </a:xfrm>
          <a:custGeom>
            <a:avLst/>
            <a:gdLst/>
            <a:ahLst/>
            <a:cxnLst/>
            <a:rect l="l" t="t" r="r" b="b"/>
            <a:pathLst>
              <a:path w="202565">
                <a:moveTo>
                  <a:pt x="0" y="0"/>
                </a:moveTo>
                <a:lnTo>
                  <a:pt x="202310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9726168" y="3283839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10107168" y="3283839"/>
            <a:ext cx="93345" cy="0"/>
          </a:xfrm>
          <a:custGeom>
            <a:avLst/>
            <a:gdLst/>
            <a:ahLst/>
            <a:cxnLst/>
            <a:rect l="l" t="t" r="r" b="b"/>
            <a:pathLst>
              <a:path w="93345">
                <a:moveTo>
                  <a:pt x="0" y="0"/>
                </a:moveTo>
                <a:lnTo>
                  <a:pt x="93344" y="0"/>
                </a:lnTo>
              </a:path>
            </a:pathLst>
          </a:custGeom>
          <a:ln w="4572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5432297" y="2926460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5812535" y="2926460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6193535" y="2929127"/>
            <a:ext cx="675640" cy="0"/>
          </a:xfrm>
          <a:custGeom>
            <a:avLst/>
            <a:gdLst/>
            <a:ahLst/>
            <a:cxnLst/>
            <a:rect l="l" t="t" r="r" b="b"/>
            <a:pathLst>
              <a:path w="675640">
                <a:moveTo>
                  <a:pt x="0" y="0"/>
                </a:moveTo>
                <a:lnTo>
                  <a:pt x="675132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6193535" y="2924175"/>
            <a:ext cx="675640" cy="0"/>
          </a:xfrm>
          <a:custGeom>
            <a:avLst/>
            <a:gdLst/>
            <a:ahLst/>
            <a:cxnLst/>
            <a:rect l="l" t="t" r="r" b="b"/>
            <a:pathLst>
              <a:path w="675640">
                <a:moveTo>
                  <a:pt x="0" y="0"/>
                </a:moveTo>
                <a:lnTo>
                  <a:pt x="675132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2589657" y="2926460"/>
            <a:ext cx="2376805" cy="0"/>
          </a:xfrm>
          <a:custGeom>
            <a:avLst/>
            <a:gdLst/>
            <a:ahLst/>
            <a:cxnLst/>
            <a:rect l="l" t="t" r="r" b="b"/>
            <a:pathLst>
              <a:path w="2376804">
                <a:moveTo>
                  <a:pt x="0" y="0"/>
                </a:moveTo>
                <a:lnTo>
                  <a:pt x="2376297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5051297" y="2926460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7335011" y="2929127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7715250" y="2929127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" name="object 79"/>
          <p:cNvSpPr/>
          <p:nvPr/>
        </p:nvSpPr>
        <p:spPr>
          <a:xfrm>
            <a:off x="7335011" y="292417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" name="object 80"/>
          <p:cNvSpPr/>
          <p:nvPr/>
        </p:nvSpPr>
        <p:spPr>
          <a:xfrm>
            <a:off x="7715250" y="292417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4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" name="object 81"/>
          <p:cNvSpPr/>
          <p:nvPr/>
        </p:nvSpPr>
        <p:spPr>
          <a:xfrm>
            <a:off x="8095488" y="2929127"/>
            <a:ext cx="676275" cy="0"/>
          </a:xfrm>
          <a:custGeom>
            <a:avLst/>
            <a:gdLst/>
            <a:ahLst/>
            <a:cxnLst/>
            <a:rect l="l" t="t" r="r" b="b"/>
            <a:pathLst>
              <a:path w="676275">
                <a:moveTo>
                  <a:pt x="0" y="0"/>
                </a:moveTo>
                <a:lnTo>
                  <a:pt x="675893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" name="object 82"/>
          <p:cNvSpPr/>
          <p:nvPr/>
        </p:nvSpPr>
        <p:spPr>
          <a:xfrm>
            <a:off x="8095488" y="2924175"/>
            <a:ext cx="676275" cy="0"/>
          </a:xfrm>
          <a:custGeom>
            <a:avLst/>
            <a:gdLst/>
            <a:ahLst/>
            <a:cxnLst/>
            <a:rect l="l" t="t" r="r" b="b"/>
            <a:pathLst>
              <a:path w="676275">
                <a:moveTo>
                  <a:pt x="0" y="0"/>
                </a:moveTo>
                <a:lnTo>
                  <a:pt x="675893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" name="object 83"/>
          <p:cNvSpPr/>
          <p:nvPr/>
        </p:nvSpPr>
        <p:spPr>
          <a:xfrm>
            <a:off x="6954011" y="2929127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" name="object 84"/>
          <p:cNvSpPr/>
          <p:nvPr/>
        </p:nvSpPr>
        <p:spPr>
          <a:xfrm>
            <a:off x="6954011" y="2924175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" name="object 85"/>
          <p:cNvSpPr/>
          <p:nvPr/>
        </p:nvSpPr>
        <p:spPr>
          <a:xfrm>
            <a:off x="8856726" y="2929127"/>
            <a:ext cx="676275" cy="0"/>
          </a:xfrm>
          <a:custGeom>
            <a:avLst/>
            <a:gdLst/>
            <a:ahLst/>
            <a:cxnLst/>
            <a:rect l="l" t="t" r="r" b="b"/>
            <a:pathLst>
              <a:path w="676275">
                <a:moveTo>
                  <a:pt x="0" y="0"/>
                </a:moveTo>
                <a:lnTo>
                  <a:pt x="675894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8856726" y="2924175"/>
            <a:ext cx="676275" cy="0"/>
          </a:xfrm>
          <a:custGeom>
            <a:avLst/>
            <a:gdLst/>
            <a:ahLst/>
            <a:cxnLst/>
            <a:rect l="l" t="t" r="r" b="b"/>
            <a:pathLst>
              <a:path w="676275">
                <a:moveTo>
                  <a:pt x="0" y="0"/>
                </a:moveTo>
                <a:lnTo>
                  <a:pt x="675894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9617964" y="2929127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" name="object 88"/>
          <p:cNvSpPr/>
          <p:nvPr/>
        </p:nvSpPr>
        <p:spPr>
          <a:xfrm>
            <a:off x="9617964" y="2924175"/>
            <a:ext cx="295275" cy="0"/>
          </a:xfrm>
          <a:custGeom>
            <a:avLst/>
            <a:gdLst/>
            <a:ahLst/>
            <a:cxnLst/>
            <a:rect l="l" t="t" r="r" b="b"/>
            <a:pathLst>
              <a:path w="295275">
                <a:moveTo>
                  <a:pt x="0" y="0"/>
                </a:moveTo>
                <a:lnTo>
                  <a:pt x="294893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" name="object 89"/>
          <p:cNvSpPr/>
          <p:nvPr/>
        </p:nvSpPr>
        <p:spPr>
          <a:xfrm>
            <a:off x="9998202" y="2929127"/>
            <a:ext cx="202565" cy="0"/>
          </a:xfrm>
          <a:custGeom>
            <a:avLst/>
            <a:gdLst/>
            <a:ahLst/>
            <a:cxnLst/>
            <a:rect l="l" t="t" r="r" b="b"/>
            <a:pathLst>
              <a:path w="202565">
                <a:moveTo>
                  <a:pt x="0" y="0"/>
                </a:moveTo>
                <a:lnTo>
                  <a:pt x="202310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9998202" y="2924175"/>
            <a:ext cx="202565" cy="0"/>
          </a:xfrm>
          <a:custGeom>
            <a:avLst/>
            <a:gdLst/>
            <a:ahLst/>
            <a:cxnLst/>
            <a:rect l="l" t="t" r="r" b="b"/>
            <a:pathLst>
              <a:path w="202565">
                <a:moveTo>
                  <a:pt x="0" y="0"/>
                </a:moveTo>
                <a:lnTo>
                  <a:pt x="202310" y="0"/>
                </a:lnTo>
              </a:path>
            </a:pathLst>
          </a:custGeom>
          <a:ln w="4571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5051297" y="2572130"/>
            <a:ext cx="676275" cy="0"/>
          </a:xfrm>
          <a:custGeom>
            <a:avLst/>
            <a:gdLst/>
            <a:ahLst/>
            <a:cxnLst/>
            <a:rect l="l" t="t" r="r" b="b"/>
            <a:pathLst>
              <a:path w="676275">
                <a:moveTo>
                  <a:pt x="0" y="0"/>
                </a:moveTo>
                <a:lnTo>
                  <a:pt x="675893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" name="object 92"/>
          <p:cNvSpPr/>
          <p:nvPr/>
        </p:nvSpPr>
        <p:spPr>
          <a:xfrm>
            <a:off x="5812535" y="2572130"/>
            <a:ext cx="295910" cy="0"/>
          </a:xfrm>
          <a:custGeom>
            <a:avLst/>
            <a:gdLst/>
            <a:ahLst/>
            <a:cxnLst/>
            <a:rect l="l" t="t" r="r" b="b"/>
            <a:pathLst>
              <a:path w="295910">
                <a:moveTo>
                  <a:pt x="0" y="0"/>
                </a:moveTo>
                <a:lnTo>
                  <a:pt x="295655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" name="object 93"/>
          <p:cNvSpPr/>
          <p:nvPr/>
        </p:nvSpPr>
        <p:spPr>
          <a:xfrm>
            <a:off x="6193535" y="2572130"/>
            <a:ext cx="1436370" cy="0"/>
          </a:xfrm>
          <a:custGeom>
            <a:avLst/>
            <a:gdLst/>
            <a:ahLst/>
            <a:cxnLst/>
            <a:rect l="l" t="t" r="r" b="b"/>
            <a:pathLst>
              <a:path w="1436370">
                <a:moveTo>
                  <a:pt x="0" y="0"/>
                </a:moveTo>
                <a:lnTo>
                  <a:pt x="1436369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2589657" y="2572130"/>
            <a:ext cx="2376805" cy="0"/>
          </a:xfrm>
          <a:custGeom>
            <a:avLst/>
            <a:gdLst/>
            <a:ahLst/>
            <a:cxnLst/>
            <a:rect l="l" t="t" r="r" b="b"/>
            <a:pathLst>
              <a:path w="2376804">
                <a:moveTo>
                  <a:pt x="0" y="0"/>
                </a:moveTo>
                <a:lnTo>
                  <a:pt x="2376297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7715250" y="2572130"/>
            <a:ext cx="2485390" cy="0"/>
          </a:xfrm>
          <a:custGeom>
            <a:avLst/>
            <a:gdLst/>
            <a:ahLst/>
            <a:cxnLst/>
            <a:rect l="l" t="t" r="r" b="b"/>
            <a:pathLst>
              <a:path w="2485390">
                <a:moveTo>
                  <a:pt x="0" y="0"/>
                </a:moveTo>
                <a:lnTo>
                  <a:pt x="2485262" y="0"/>
                </a:lnTo>
              </a:path>
            </a:pathLst>
          </a:custGeom>
          <a:ln w="9905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6" name="object 96"/>
          <p:cNvSpPr/>
          <p:nvPr/>
        </p:nvSpPr>
        <p:spPr>
          <a:xfrm>
            <a:off x="2589657" y="2217039"/>
            <a:ext cx="7611109" cy="0"/>
          </a:xfrm>
          <a:custGeom>
            <a:avLst/>
            <a:gdLst/>
            <a:ahLst/>
            <a:cxnLst/>
            <a:rect l="l" t="t" r="r" b="b"/>
            <a:pathLst>
              <a:path w="7611109">
                <a:moveTo>
                  <a:pt x="0" y="0"/>
                </a:moveTo>
                <a:lnTo>
                  <a:pt x="7610856" y="0"/>
                </a:lnTo>
              </a:path>
            </a:pathLst>
          </a:custGeom>
          <a:ln w="9906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7" name="object 97"/>
          <p:cNvSpPr/>
          <p:nvPr/>
        </p:nvSpPr>
        <p:spPr>
          <a:xfrm>
            <a:off x="2683001" y="3121914"/>
            <a:ext cx="85725" cy="159385"/>
          </a:xfrm>
          <a:custGeom>
            <a:avLst/>
            <a:gdLst/>
            <a:ahLst/>
            <a:cxnLst/>
            <a:rect l="l" t="t" r="r" b="b"/>
            <a:pathLst>
              <a:path w="85725" h="159385">
                <a:moveTo>
                  <a:pt x="85343" y="0"/>
                </a:moveTo>
                <a:lnTo>
                  <a:pt x="0" y="0"/>
                </a:lnTo>
                <a:lnTo>
                  <a:pt x="0" y="159258"/>
                </a:lnTo>
                <a:lnTo>
                  <a:pt x="85343" y="159258"/>
                </a:lnTo>
                <a:lnTo>
                  <a:pt x="85343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8" name="object 98"/>
          <p:cNvSpPr/>
          <p:nvPr/>
        </p:nvSpPr>
        <p:spPr>
          <a:xfrm>
            <a:off x="3063239" y="3156966"/>
            <a:ext cx="85725" cy="124460"/>
          </a:xfrm>
          <a:custGeom>
            <a:avLst/>
            <a:gdLst/>
            <a:ahLst/>
            <a:cxnLst/>
            <a:rect l="l" t="t" r="r" b="b"/>
            <a:pathLst>
              <a:path w="85725" h="124460">
                <a:moveTo>
                  <a:pt x="85343" y="0"/>
                </a:moveTo>
                <a:lnTo>
                  <a:pt x="0" y="0"/>
                </a:lnTo>
                <a:lnTo>
                  <a:pt x="0" y="124205"/>
                </a:lnTo>
                <a:lnTo>
                  <a:pt x="85343" y="124205"/>
                </a:lnTo>
                <a:lnTo>
                  <a:pt x="85343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9" name="object 99"/>
          <p:cNvSpPr/>
          <p:nvPr/>
        </p:nvSpPr>
        <p:spPr>
          <a:xfrm>
            <a:off x="3444240" y="3281171"/>
            <a:ext cx="85725" cy="284480"/>
          </a:xfrm>
          <a:custGeom>
            <a:avLst/>
            <a:gdLst/>
            <a:ahLst/>
            <a:cxnLst/>
            <a:rect l="l" t="t" r="r" b="b"/>
            <a:pathLst>
              <a:path w="85725" h="284479">
                <a:moveTo>
                  <a:pt x="85344" y="0"/>
                </a:moveTo>
                <a:lnTo>
                  <a:pt x="0" y="0"/>
                </a:lnTo>
                <a:lnTo>
                  <a:pt x="0" y="284225"/>
                </a:lnTo>
                <a:lnTo>
                  <a:pt x="85344" y="284225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0" name="object 100"/>
          <p:cNvSpPr/>
          <p:nvPr/>
        </p:nvSpPr>
        <p:spPr>
          <a:xfrm>
            <a:off x="3824478" y="3281171"/>
            <a:ext cx="85725" cy="1144270"/>
          </a:xfrm>
          <a:custGeom>
            <a:avLst/>
            <a:gdLst/>
            <a:ahLst/>
            <a:cxnLst/>
            <a:rect l="l" t="t" r="r" b="b"/>
            <a:pathLst>
              <a:path w="85725" h="1144270">
                <a:moveTo>
                  <a:pt x="85344" y="0"/>
                </a:moveTo>
                <a:lnTo>
                  <a:pt x="0" y="0"/>
                </a:lnTo>
                <a:lnTo>
                  <a:pt x="0" y="1143761"/>
                </a:lnTo>
                <a:lnTo>
                  <a:pt x="85344" y="1143761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1" name="object 101"/>
          <p:cNvSpPr/>
          <p:nvPr/>
        </p:nvSpPr>
        <p:spPr>
          <a:xfrm>
            <a:off x="4205478" y="3281171"/>
            <a:ext cx="85725" cy="1330960"/>
          </a:xfrm>
          <a:custGeom>
            <a:avLst/>
            <a:gdLst/>
            <a:ahLst/>
            <a:cxnLst/>
            <a:rect l="l" t="t" r="r" b="b"/>
            <a:pathLst>
              <a:path w="85725" h="1330960">
                <a:moveTo>
                  <a:pt x="85344" y="0"/>
                </a:moveTo>
                <a:lnTo>
                  <a:pt x="0" y="0"/>
                </a:lnTo>
                <a:lnTo>
                  <a:pt x="0" y="1330452"/>
                </a:lnTo>
                <a:lnTo>
                  <a:pt x="85344" y="1330452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2" name="object 102"/>
          <p:cNvSpPr/>
          <p:nvPr/>
        </p:nvSpPr>
        <p:spPr>
          <a:xfrm>
            <a:off x="4585715" y="3281171"/>
            <a:ext cx="85725" cy="1117600"/>
          </a:xfrm>
          <a:custGeom>
            <a:avLst/>
            <a:gdLst/>
            <a:ahLst/>
            <a:cxnLst/>
            <a:rect l="l" t="t" r="r" b="b"/>
            <a:pathLst>
              <a:path w="85725" h="1117600">
                <a:moveTo>
                  <a:pt x="85344" y="0"/>
                </a:moveTo>
                <a:lnTo>
                  <a:pt x="0" y="0"/>
                </a:lnTo>
                <a:lnTo>
                  <a:pt x="0" y="1117091"/>
                </a:lnTo>
                <a:lnTo>
                  <a:pt x="85344" y="1117091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4965953" y="2483357"/>
            <a:ext cx="85725" cy="798195"/>
          </a:xfrm>
          <a:custGeom>
            <a:avLst/>
            <a:gdLst/>
            <a:ahLst/>
            <a:cxnLst/>
            <a:rect l="l" t="t" r="r" b="b"/>
            <a:pathLst>
              <a:path w="85725" h="798195">
                <a:moveTo>
                  <a:pt x="85344" y="0"/>
                </a:moveTo>
                <a:lnTo>
                  <a:pt x="0" y="0"/>
                </a:lnTo>
                <a:lnTo>
                  <a:pt x="0" y="797813"/>
                </a:lnTo>
                <a:lnTo>
                  <a:pt x="85344" y="797813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5346953" y="2607564"/>
            <a:ext cx="85725" cy="673735"/>
          </a:xfrm>
          <a:custGeom>
            <a:avLst/>
            <a:gdLst/>
            <a:ahLst/>
            <a:cxnLst/>
            <a:rect l="l" t="t" r="r" b="b"/>
            <a:pathLst>
              <a:path w="85725" h="673735">
                <a:moveTo>
                  <a:pt x="85344" y="0"/>
                </a:moveTo>
                <a:lnTo>
                  <a:pt x="0" y="0"/>
                </a:lnTo>
                <a:lnTo>
                  <a:pt x="0" y="673608"/>
                </a:lnTo>
                <a:lnTo>
                  <a:pt x="85344" y="673608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5727191" y="2500883"/>
            <a:ext cx="85725" cy="780415"/>
          </a:xfrm>
          <a:custGeom>
            <a:avLst/>
            <a:gdLst/>
            <a:ahLst/>
            <a:cxnLst/>
            <a:rect l="l" t="t" r="r" b="b"/>
            <a:pathLst>
              <a:path w="85725" h="780414">
                <a:moveTo>
                  <a:pt x="85344" y="0"/>
                </a:moveTo>
                <a:lnTo>
                  <a:pt x="0" y="0"/>
                </a:lnTo>
                <a:lnTo>
                  <a:pt x="0" y="780288"/>
                </a:lnTo>
                <a:lnTo>
                  <a:pt x="85344" y="780288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6108191" y="2359151"/>
            <a:ext cx="85725" cy="922019"/>
          </a:xfrm>
          <a:custGeom>
            <a:avLst/>
            <a:gdLst/>
            <a:ahLst/>
            <a:cxnLst/>
            <a:rect l="l" t="t" r="r" b="b"/>
            <a:pathLst>
              <a:path w="85725" h="922020">
                <a:moveTo>
                  <a:pt x="85344" y="0"/>
                </a:moveTo>
                <a:lnTo>
                  <a:pt x="0" y="0"/>
                </a:lnTo>
                <a:lnTo>
                  <a:pt x="0" y="922020"/>
                </a:lnTo>
                <a:lnTo>
                  <a:pt x="85344" y="922020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6488429" y="2926842"/>
            <a:ext cx="85725" cy="354330"/>
          </a:xfrm>
          <a:custGeom>
            <a:avLst/>
            <a:gdLst/>
            <a:ahLst/>
            <a:cxnLst/>
            <a:rect l="l" t="t" r="r" b="b"/>
            <a:pathLst>
              <a:path w="85725" h="354329">
                <a:moveTo>
                  <a:pt x="85344" y="0"/>
                </a:moveTo>
                <a:lnTo>
                  <a:pt x="0" y="0"/>
                </a:lnTo>
                <a:lnTo>
                  <a:pt x="0" y="354329"/>
                </a:lnTo>
                <a:lnTo>
                  <a:pt x="85344" y="354329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6868668" y="2784348"/>
            <a:ext cx="85725" cy="497205"/>
          </a:xfrm>
          <a:custGeom>
            <a:avLst/>
            <a:gdLst/>
            <a:ahLst/>
            <a:cxnLst/>
            <a:rect l="l" t="t" r="r" b="b"/>
            <a:pathLst>
              <a:path w="85725" h="497204">
                <a:moveTo>
                  <a:pt x="85344" y="0"/>
                </a:moveTo>
                <a:lnTo>
                  <a:pt x="0" y="0"/>
                </a:lnTo>
                <a:lnTo>
                  <a:pt x="0" y="496824"/>
                </a:lnTo>
                <a:lnTo>
                  <a:pt x="85344" y="496824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7249668" y="2917698"/>
            <a:ext cx="85725" cy="363855"/>
          </a:xfrm>
          <a:custGeom>
            <a:avLst/>
            <a:gdLst/>
            <a:ahLst/>
            <a:cxnLst/>
            <a:rect l="l" t="t" r="r" b="b"/>
            <a:pathLst>
              <a:path w="85725" h="363854">
                <a:moveTo>
                  <a:pt x="85344" y="0"/>
                </a:moveTo>
                <a:lnTo>
                  <a:pt x="0" y="0"/>
                </a:lnTo>
                <a:lnTo>
                  <a:pt x="0" y="363474"/>
                </a:lnTo>
                <a:lnTo>
                  <a:pt x="85344" y="363474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7629906" y="2385822"/>
            <a:ext cx="85725" cy="895350"/>
          </a:xfrm>
          <a:custGeom>
            <a:avLst/>
            <a:gdLst/>
            <a:ahLst/>
            <a:cxnLst/>
            <a:rect l="l" t="t" r="r" b="b"/>
            <a:pathLst>
              <a:path w="85725" h="895350">
                <a:moveTo>
                  <a:pt x="85344" y="0"/>
                </a:moveTo>
                <a:lnTo>
                  <a:pt x="0" y="0"/>
                </a:lnTo>
                <a:lnTo>
                  <a:pt x="0" y="895350"/>
                </a:lnTo>
                <a:lnTo>
                  <a:pt x="85344" y="895350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8010143" y="2802635"/>
            <a:ext cx="85725" cy="478790"/>
          </a:xfrm>
          <a:custGeom>
            <a:avLst/>
            <a:gdLst/>
            <a:ahLst/>
            <a:cxnLst/>
            <a:rect l="l" t="t" r="r" b="b"/>
            <a:pathLst>
              <a:path w="85725" h="478789">
                <a:moveTo>
                  <a:pt x="85344" y="0"/>
                </a:moveTo>
                <a:lnTo>
                  <a:pt x="0" y="0"/>
                </a:lnTo>
                <a:lnTo>
                  <a:pt x="0" y="478536"/>
                </a:lnTo>
                <a:lnTo>
                  <a:pt x="85344" y="478536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8391143" y="2988564"/>
            <a:ext cx="85725" cy="292735"/>
          </a:xfrm>
          <a:custGeom>
            <a:avLst/>
            <a:gdLst/>
            <a:ahLst/>
            <a:cxnLst/>
            <a:rect l="l" t="t" r="r" b="b"/>
            <a:pathLst>
              <a:path w="85725" h="292735">
                <a:moveTo>
                  <a:pt x="85344" y="0"/>
                </a:moveTo>
                <a:lnTo>
                  <a:pt x="0" y="0"/>
                </a:lnTo>
                <a:lnTo>
                  <a:pt x="0" y="292608"/>
                </a:lnTo>
                <a:lnTo>
                  <a:pt x="85344" y="292608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8771381" y="2908554"/>
            <a:ext cx="85725" cy="372745"/>
          </a:xfrm>
          <a:custGeom>
            <a:avLst/>
            <a:gdLst/>
            <a:ahLst/>
            <a:cxnLst/>
            <a:rect l="l" t="t" r="r" b="b"/>
            <a:pathLst>
              <a:path w="85725" h="372745">
                <a:moveTo>
                  <a:pt x="85344" y="0"/>
                </a:moveTo>
                <a:lnTo>
                  <a:pt x="0" y="0"/>
                </a:lnTo>
                <a:lnTo>
                  <a:pt x="0" y="372617"/>
                </a:lnTo>
                <a:lnTo>
                  <a:pt x="85344" y="372617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9152381" y="2944367"/>
            <a:ext cx="85725" cy="337185"/>
          </a:xfrm>
          <a:custGeom>
            <a:avLst/>
            <a:gdLst/>
            <a:ahLst/>
            <a:cxnLst/>
            <a:rect l="l" t="t" r="r" b="b"/>
            <a:pathLst>
              <a:path w="85725" h="337185">
                <a:moveTo>
                  <a:pt x="85344" y="0"/>
                </a:moveTo>
                <a:lnTo>
                  <a:pt x="0" y="0"/>
                </a:lnTo>
                <a:lnTo>
                  <a:pt x="0" y="336803"/>
                </a:lnTo>
                <a:lnTo>
                  <a:pt x="85344" y="336803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9532619" y="2717292"/>
            <a:ext cx="85725" cy="563880"/>
          </a:xfrm>
          <a:custGeom>
            <a:avLst/>
            <a:gdLst/>
            <a:ahLst/>
            <a:cxnLst/>
            <a:rect l="l" t="t" r="r" b="b"/>
            <a:pathLst>
              <a:path w="85725" h="563879">
                <a:moveTo>
                  <a:pt x="85344" y="0"/>
                </a:moveTo>
                <a:lnTo>
                  <a:pt x="0" y="0"/>
                </a:lnTo>
                <a:lnTo>
                  <a:pt x="0" y="563879"/>
                </a:lnTo>
                <a:lnTo>
                  <a:pt x="85344" y="563879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9912857" y="2726435"/>
            <a:ext cx="85725" cy="554990"/>
          </a:xfrm>
          <a:custGeom>
            <a:avLst/>
            <a:gdLst/>
            <a:ahLst/>
            <a:cxnLst/>
            <a:rect l="l" t="t" r="r" b="b"/>
            <a:pathLst>
              <a:path w="85725" h="554989">
                <a:moveTo>
                  <a:pt x="85344" y="0"/>
                </a:moveTo>
                <a:lnTo>
                  <a:pt x="0" y="0"/>
                </a:lnTo>
                <a:lnTo>
                  <a:pt x="0" y="554736"/>
                </a:lnTo>
                <a:lnTo>
                  <a:pt x="85344" y="554736"/>
                </a:lnTo>
                <a:lnTo>
                  <a:pt x="85344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2791205" y="3281171"/>
            <a:ext cx="85725" cy="118110"/>
          </a:xfrm>
          <a:custGeom>
            <a:avLst/>
            <a:gdLst/>
            <a:ahLst/>
            <a:cxnLst/>
            <a:rect l="l" t="t" r="r" b="b"/>
            <a:pathLst>
              <a:path w="85725" h="118110">
                <a:moveTo>
                  <a:pt x="85343" y="0"/>
                </a:moveTo>
                <a:lnTo>
                  <a:pt x="0" y="0"/>
                </a:lnTo>
                <a:lnTo>
                  <a:pt x="0" y="118110"/>
                </a:lnTo>
                <a:lnTo>
                  <a:pt x="85343" y="118110"/>
                </a:lnTo>
                <a:lnTo>
                  <a:pt x="85343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3172205" y="3281171"/>
            <a:ext cx="85725" cy="47625"/>
          </a:xfrm>
          <a:custGeom>
            <a:avLst/>
            <a:gdLst/>
            <a:ahLst/>
            <a:cxnLst/>
            <a:rect l="l" t="t" r="r" b="b"/>
            <a:pathLst>
              <a:path w="85725" h="47625">
                <a:moveTo>
                  <a:pt x="85343" y="0"/>
                </a:moveTo>
                <a:lnTo>
                  <a:pt x="0" y="0"/>
                </a:lnTo>
                <a:lnTo>
                  <a:pt x="0" y="47244"/>
                </a:lnTo>
                <a:lnTo>
                  <a:pt x="85343" y="47244"/>
                </a:lnTo>
                <a:lnTo>
                  <a:pt x="85343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3552444" y="3115817"/>
            <a:ext cx="85725" cy="165735"/>
          </a:xfrm>
          <a:custGeom>
            <a:avLst/>
            <a:gdLst/>
            <a:ahLst/>
            <a:cxnLst/>
            <a:rect l="l" t="t" r="r" b="b"/>
            <a:pathLst>
              <a:path w="85725" h="165735">
                <a:moveTo>
                  <a:pt x="85344" y="0"/>
                </a:moveTo>
                <a:lnTo>
                  <a:pt x="0" y="0"/>
                </a:lnTo>
                <a:lnTo>
                  <a:pt x="0" y="165353"/>
                </a:lnTo>
                <a:lnTo>
                  <a:pt x="85344" y="165353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3932682" y="3115817"/>
            <a:ext cx="85725" cy="165735"/>
          </a:xfrm>
          <a:custGeom>
            <a:avLst/>
            <a:gdLst/>
            <a:ahLst/>
            <a:cxnLst/>
            <a:rect l="l" t="t" r="r" b="b"/>
            <a:pathLst>
              <a:path w="85725" h="165735">
                <a:moveTo>
                  <a:pt x="85344" y="0"/>
                </a:moveTo>
                <a:lnTo>
                  <a:pt x="0" y="0"/>
                </a:lnTo>
                <a:lnTo>
                  <a:pt x="0" y="165353"/>
                </a:lnTo>
                <a:lnTo>
                  <a:pt x="85344" y="165353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4313682" y="3062477"/>
            <a:ext cx="85725" cy="219075"/>
          </a:xfrm>
          <a:custGeom>
            <a:avLst/>
            <a:gdLst/>
            <a:ahLst/>
            <a:cxnLst/>
            <a:rect l="l" t="t" r="r" b="b"/>
            <a:pathLst>
              <a:path w="85725" h="219075">
                <a:moveTo>
                  <a:pt x="85344" y="0"/>
                </a:moveTo>
                <a:lnTo>
                  <a:pt x="0" y="0"/>
                </a:lnTo>
                <a:lnTo>
                  <a:pt x="0" y="218694"/>
                </a:lnTo>
                <a:lnTo>
                  <a:pt x="85344" y="218694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4693920" y="3000755"/>
            <a:ext cx="85725" cy="280670"/>
          </a:xfrm>
          <a:custGeom>
            <a:avLst/>
            <a:gdLst/>
            <a:ahLst/>
            <a:cxnLst/>
            <a:rect l="l" t="t" r="r" b="b"/>
            <a:pathLst>
              <a:path w="85725" h="280670">
                <a:moveTo>
                  <a:pt x="85344" y="0"/>
                </a:moveTo>
                <a:lnTo>
                  <a:pt x="0" y="0"/>
                </a:lnTo>
                <a:lnTo>
                  <a:pt x="0" y="280415"/>
                </a:lnTo>
                <a:lnTo>
                  <a:pt x="85344" y="280415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5074920" y="3281171"/>
            <a:ext cx="85725" cy="517525"/>
          </a:xfrm>
          <a:custGeom>
            <a:avLst/>
            <a:gdLst/>
            <a:ahLst/>
            <a:cxnLst/>
            <a:rect l="l" t="t" r="r" b="b"/>
            <a:pathLst>
              <a:path w="85725" h="517525">
                <a:moveTo>
                  <a:pt x="85344" y="0"/>
                </a:moveTo>
                <a:lnTo>
                  <a:pt x="0" y="0"/>
                </a:lnTo>
                <a:lnTo>
                  <a:pt x="0" y="517397"/>
                </a:lnTo>
                <a:lnTo>
                  <a:pt x="85344" y="517397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5455158" y="3281171"/>
            <a:ext cx="85725" cy="570865"/>
          </a:xfrm>
          <a:custGeom>
            <a:avLst/>
            <a:gdLst/>
            <a:ahLst/>
            <a:cxnLst/>
            <a:rect l="l" t="t" r="r" b="b"/>
            <a:pathLst>
              <a:path w="85725" h="570864">
                <a:moveTo>
                  <a:pt x="85344" y="0"/>
                </a:moveTo>
                <a:lnTo>
                  <a:pt x="0" y="0"/>
                </a:lnTo>
                <a:lnTo>
                  <a:pt x="0" y="570738"/>
                </a:lnTo>
                <a:lnTo>
                  <a:pt x="85344" y="570738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5835396" y="3281171"/>
            <a:ext cx="85725" cy="908050"/>
          </a:xfrm>
          <a:custGeom>
            <a:avLst/>
            <a:gdLst/>
            <a:ahLst/>
            <a:cxnLst/>
            <a:rect l="l" t="t" r="r" b="b"/>
            <a:pathLst>
              <a:path w="85725" h="908050">
                <a:moveTo>
                  <a:pt x="85344" y="0"/>
                </a:moveTo>
                <a:lnTo>
                  <a:pt x="0" y="0"/>
                </a:lnTo>
                <a:lnTo>
                  <a:pt x="0" y="907541"/>
                </a:lnTo>
                <a:lnTo>
                  <a:pt x="85344" y="907541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6216396" y="3240023"/>
            <a:ext cx="85725" cy="41275"/>
          </a:xfrm>
          <a:custGeom>
            <a:avLst/>
            <a:gdLst/>
            <a:ahLst/>
            <a:cxnLst/>
            <a:rect l="l" t="t" r="r" b="b"/>
            <a:pathLst>
              <a:path w="85725" h="41275">
                <a:moveTo>
                  <a:pt x="85344" y="0"/>
                </a:moveTo>
                <a:lnTo>
                  <a:pt x="0" y="0"/>
                </a:lnTo>
                <a:lnTo>
                  <a:pt x="0" y="41148"/>
                </a:lnTo>
                <a:lnTo>
                  <a:pt x="85344" y="41148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6596633" y="3257550"/>
            <a:ext cx="85725" cy="24130"/>
          </a:xfrm>
          <a:custGeom>
            <a:avLst/>
            <a:gdLst/>
            <a:ahLst/>
            <a:cxnLst/>
            <a:rect l="l" t="t" r="r" b="b"/>
            <a:pathLst>
              <a:path w="85725" h="24129">
                <a:moveTo>
                  <a:pt x="85344" y="0"/>
                </a:moveTo>
                <a:lnTo>
                  <a:pt x="0" y="0"/>
                </a:lnTo>
                <a:lnTo>
                  <a:pt x="0" y="23622"/>
                </a:lnTo>
                <a:lnTo>
                  <a:pt x="85344" y="23622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8" name="object 128"/>
          <p:cNvSpPr/>
          <p:nvPr/>
        </p:nvSpPr>
        <p:spPr>
          <a:xfrm>
            <a:off x="6977633" y="3281171"/>
            <a:ext cx="85090" cy="349250"/>
          </a:xfrm>
          <a:custGeom>
            <a:avLst/>
            <a:gdLst/>
            <a:ahLst/>
            <a:cxnLst/>
            <a:rect l="l" t="t" r="r" b="b"/>
            <a:pathLst>
              <a:path w="85090" h="349250">
                <a:moveTo>
                  <a:pt x="84581" y="0"/>
                </a:moveTo>
                <a:lnTo>
                  <a:pt x="0" y="0"/>
                </a:lnTo>
                <a:lnTo>
                  <a:pt x="0" y="348995"/>
                </a:lnTo>
                <a:lnTo>
                  <a:pt x="84581" y="348995"/>
                </a:lnTo>
                <a:lnTo>
                  <a:pt x="84581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9" name="object 129"/>
          <p:cNvSpPr/>
          <p:nvPr/>
        </p:nvSpPr>
        <p:spPr>
          <a:xfrm>
            <a:off x="7357871" y="3281171"/>
            <a:ext cx="85725" cy="473709"/>
          </a:xfrm>
          <a:custGeom>
            <a:avLst/>
            <a:gdLst/>
            <a:ahLst/>
            <a:cxnLst/>
            <a:rect l="l" t="t" r="r" b="b"/>
            <a:pathLst>
              <a:path w="85725" h="473710">
                <a:moveTo>
                  <a:pt x="85344" y="0"/>
                </a:moveTo>
                <a:lnTo>
                  <a:pt x="0" y="0"/>
                </a:lnTo>
                <a:lnTo>
                  <a:pt x="0" y="473201"/>
                </a:lnTo>
                <a:lnTo>
                  <a:pt x="85344" y="473201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0" name="object 130"/>
          <p:cNvSpPr/>
          <p:nvPr/>
        </p:nvSpPr>
        <p:spPr>
          <a:xfrm>
            <a:off x="7738109" y="3281171"/>
            <a:ext cx="85725" cy="801370"/>
          </a:xfrm>
          <a:custGeom>
            <a:avLst/>
            <a:gdLst/>
            <a:ahLst/>
            <a:cxnLst/>
            <a:rect l="l" t="t" r="r" b="b"/>
            <a:pathLst>
              <a:path w="85725" h="801370">
                <a:moveTo>
                  <a:pt x="85344" y="0"/>
                </a:moveTo>
                <a:lnTo>
                  <a:pt x="0" y="0"/>
                </a:lnTo>
                <a:lnTo>
                  <a:pt x="0" y="800861"/>
                </a:lnTo>
                <a:lnTo>
                  <a:pt x="85344" y="800861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1" name="object 131"/>
          <p:cNvSpPr/>
          <p:nvPr/>
        </p:nvSpPr>
        <p:spPr>
          <a:xfrm>
            <a:off x="8119109" y="3281171"/>
            <a:ext cx="85725" cy="527050"/>
          </a:xfrm>
          <a:custGeom>
            <a:avLst/>
            <a:gdLst/>
            <a:ahLst/>
            <a:cxnLst/>
            <a:rect l="l" t="t" r="r" b="b"/>
            <a:pathLst>
              <a:path w="85725" h="527050">
                <a:moveTo>
                  <a:pt x="85344" y="0"/>
                </a:moveTo>
                <a:lnTo>
                  <a:pt x="0" y="0"/>
                </a:lnTo>
                <a:lnTo>
                  <a:pt x="0" y="526541"/>
                </a:lnTo>
                <a:lnTo>
                  <a:pt x="85344" y="526541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8499347" y="3281171"/>
            <a:ext cx="85725" cy="978535"/>
          </a:xfrm>
          <a:custGeom>
            <a:avLst/>
            <a:gdLst/>
            <a:ahLst/>
            <a:cxnLst/>
            <a:rect l="l" t="t" r="r" b="b"/>
            <a:pathLst>
              <a:path w="85725" h="978535">
                <a:moveTo>
                  <a:pt x="85344" y="0"/>
                </a:moveTo>
                <a:lnTo>
                  <a:pt x="0" y="0"/>
                </a:lnTo>
                <a:lnTo>
                  <a:pt x="0" y="978407"/>
                </a:lnTo>
                <a:lnTo>
                  <a:pt x="85344" y="978407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3" name="object 133"/>
          <p:cNvSpPr/>
          <p:nvPr/>
        </p:nvSpPr>
        <p:spPr>
          <a:xfrm>
            <a:off x="8879585" y="3281171"/>
            <a:ext cx="85725" cy="943610"/>
          </a:xfrm>
          <a:custGeom>
            <a:avLst/>
            <a:gdLst/>
            <a:ahLst/>
            <a:cxnLst/>
            <a:rect l="l" t="t" r="r" b="b"/>
            <a:pathLst>
              <a:path w="85725" h="943610">
                <a:moveTo>
                  <a:pt x="85344" y="0"/>
                </a:moveTo>
                <a:lnTo>
                  <a:pt x="0" y="0"/>
                </a:lnTo>
                <a:lnTo>
                  <a:pt x="0" y="943355"/>
                </a:lnTo>
                <a:lnTo>
                  <a:pt x="85344" y="943355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4" name="object 134"/>
          <p:cNvSpPr/>
          <p:nvPr/>
        </p:nvSpPr>
        <p:spPr>
          <a:xfrm>
            <a:off x="9260585" y="3281171"/>
            <a:ext cx="85725" cy="1014730"/>
          </a:xfrm>
          <a:custGeom>
            <a:avLst/>
            <a:gdLst/>
            <a:ahLst/>
            <a:cxnLst/>
            <a:rect l="l" t="t" r="r" b="b"/>
            <a:pathLst>
              <a:path w="85725" h="1014729">
                <a:moveTo>
                  <a:pt x="85344" y="0"/>
                </a:moveTo>
                <a:lnTo>
                  <a:pt x="0" y="0"/>
                </a:lnTo>
                <a:lnTo>
                  <a:pt x="0" y="1014221"/>
                </a:lnTo>
                <a:lnTo>
                  <a:pt x="85344" y="1014221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9640823" y="3281171"/>
            <a:ext cx="85725" cy="584835"/>
          </a:xfrm>
          <a:custGeom>
            <a:avLst/>
            <a:gdLst/>
            <a:ahLst/>
            <a:cxnLst/>
            <a:rect l="l" t="t" r="r" b="b"/>
            <a:pathLst>
              <a:path w="85725" h="584835">
                <a:moveTo>
                  <a:pt x="85344" y="0"/>
                </a:moveTo>
                <a:lnTo>
                  <a:pt x="0" y="0"/>
                </a:lnTo>
                <a:lnTo>
                  <a:pt x="0" y="584453"/>
                </a:lnTo>
                <a:lnTo>
                  <a:pt x="85344" y="584453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10021823" y="3281171"/>
            <a:ext cx="85725" cy="748665"/>
          </a:xfrm>
          <a:custGeom>
            <a:avLst/>
            <a:gdLst/>
            <a:ahLst/>
            <a:cxnLst/>
            <a:rect l="l" t="t" r="r" b="b"/>
            <a:pathLst>
              <a:path w="85725" h="748664">
                <a:moveTo>
                  <a:pt x="85344" y="0"/>
                </a:moveTo>
                <a:lnTo>
                  <a:pt x="0" y="0"/>
                </a:lnTo>
                <a:lnTo>
                  <a:pt x="0" y="748283"/>
                </a:lnTo>
                <a:lnTo>
                  <a:pt x="85344" y="748283"/>
                </a:lnTo>
                <a:lnTo>
                  <a:pt x="85344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" name="object 137"/>
          <p:cNvSpPr txBox="1"/>
          <p:nvPr/>
        </p:nvSpPr>
        <p:spPr>
          <a:xfrm>
            <a:off x="2291228" y="2123401"/>
            <a:ext cx="205740" cy="30003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0.6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615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0.4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610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0.2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615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615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-</a:t>
            </a:r>
            <a:r>
              <a:rPr sz="900" spc="-5" dirty="0">
                <a:solidFill>
                  <a:srgbClr val="585858"/>
                </a:solidFill>
                <a:latin typeface="Calibri"/>
                <a:cs typeface="Calibri"/>
              </a:rPr>
              <a:t>0</a:t>
            </a: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.2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615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-</a:t>
            </a:r>
            <a:r>
              <a:rPr sz="900" spc="-5" dirty="0">
                <a:solidFill>
                  <a:srgbClr val="585858"/>
                </a:solidFill>
                <a:latin typeface="Calibri"/>
                <a:cs typeface="Calibri"/>
              </a:rPr>
              <a:t>0</a:t>
            </a: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.4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615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-</a:t>
            </a:r>
            <a:r>
              <a:rPr sz="900" spc="-5" dirty="0">
                <a:solidFill>
                  <a:srgbClr val="585858"/>
                </a:solidFill>
                <a:latin typeface="Calibri"/>
                <a:cs typeface="Calibri"/>
              </a:rPr>
              <a:t>0</a:t>
            </a: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.6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610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-</a:t>
            </a:r>
            <a:r>
              <a:rPr sz="900" spc="-5" dirty="0">
                <a:solidFill>
                  <a:srgbClr val="585858"/>
                </a:solidFill>
                <a:latin typeface="Calibri"/>
                <a:cs typeface="Calibri"/>
              </a:rPr>
              <a:t>0</a:t>
            </a: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.8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615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-1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38" name="object 138"/>
          <p:cNvSpPr/>
          <p:nvPr/>
        </p:nvSpPr>
        <p:spPr>
          <a:xfrm>
            <a:off x="5406390" y="5308091"/>
            <a:ext cx="125730" cy="125730"/>
          </a:xfrm>
          <a:custGeom>
            <a:avLst/>
            <a:gdLst/>
            <a:ahLst/>
            <a:cxnLst/>
            <a:rect l="l" t="t" r="r" b="b"/>
            <a:pathLst>
              <a:path w="125729" h="125729">
                <a:moveTo>
                  <a:pt x="125729" y="0"/>
                </a:moveTo>
                <a:lnTo>
                  <a:pt x="0" y="0"/>
                </a:lnTo>
                <a:lnTo>
                  <a:pt x="0" y="125730"/>
                </a:lnTo>
                <a:lnTo>
                  <a:pt x="125729" y="125730"/>
                </a:lnTo>
                <a:lnTo>
                  <a:pt x="125729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6478523" y="5308091"/>
            <a:ext cx="125730" cy="125730"/>
          </a:xfrm>
          <a:custGeom>
            <a:avLst/>
            <a:gdLst/>
            <a:ahLst/>
            <a:cxnLst/>
            <a:rect l="l" t="t" r="r" b="b"/>
            <a:pathLst>
              <a:path w="125729" h="125729">
                <a:moveTo>
                  <a:pt x="125729" y="0"/>
                </a:moveTo>
                <a:lnTo>
                  <a:pt x="0" y="0"/>
                </a:lnTo>
                <a:lnTo>
                  <a:pt x="0" y="125730"/>
                </a:lnTo>
                <a:lnTo>
                  <a:pt x="125729" y="125730"/>
                </a:lnTo>
                <a:lnTo>
                  <a:pt x="125729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0" name="object 140"/>
          <p:cNvSpPr txBox="1"/>
          <p:nvPr/>
        </p:nvSpPr>
        <p:spPr>
          <a:xfrm>
            <a:off x="1573725" y="5195292"/>
            <a:ext cx="9043670" cy="68993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30555" algn="ctr">
              <a:lnSpc>
                <a:spcPct val="100000"/>
              </a:lnSpc>
              <a:spcBef>
                <a:spcPts val="100"/>
              </a:spcBef>
              <a:tabLst>
                <a:tab pos="1702435" algn="l"/>
              </a:tabLst>
            </a:pPr>
            <a:r>
              <a:rPr sz="1800" spc="-5" dirty="0">
                <a:solidFill>
                  <a:srgbClr val="585858"/>
                </a:solidFill>
                <a:latin typeface="Calibri"/>
                <a:cs typeface="Calibri"/>
              </a:rPr>
              <a:t>WNT7B	TCF20</a:t>
            </a:r>
            <a:endParaRPr sz="18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2600" dirty="0">
              <a:latin typeface="Calibri"/>
              <a:cs typeface="Calibri"/>
            </a:endParaRPr>
          </a:p>
        </p:txBody>
      </p:sp>
      <p:sp>
        <p:nvSpPr>
          <p:cNvPr id="142" name="object 142"/>
          <p:cNvSpPr/>
          <p:nvPr/>
        </p:nvSpPr>
        <p:spPr>
          <a:xfrm>
            <a:off x="2671572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3" name="object 143"/>
          <p:cNvSpPr txBox="1"/>
          <p:nvPr/>
        </p:nvSpPr>
        <p:spPr>
          <a:xfrm>
            <a:off x="2057193" y="3053331"/>
            <a:ext cx="165100" cy="53594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145"/>
              </a:lnSpc>
            </a:pPr>
            <a:r>
              <a:rPr sz="1100" spc="-5" dirty="0">
                <a:latin typeface="Calibri"/>
                <a:cs typeface="Calibri"/>
              </a:rPr>
              <a:t>log2ratio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144" name="object 144"/>
          <p:cNvSpPr/>
          <p:nvPr/>
        </p:nvSpPr>
        <p:spPr>
          <a:xfrm>
            <a:off x="3073907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3467100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3854958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4232909" y="1984723"/>
            <a:ext cx="626745" cy="0"/>
          </a:xfrm>
          <a:custGeom>
            <a:avLst/>
            <a:gdLst/>
            <a:ahLst/>
            <a:cxnLst/>
            <a:rect l="l" t="t" r="r" b="b"/>
            <a:pathLst>
              <a:path w="626745">
                <a:moveTo>
                  <a:pt x="0" y="0"/>
                </a:moveTo>
                <a:lnTo>
                  <a:pt x="294779" y="0"/>
                </a:lnTo>
              </a:path>
              <a:path w="626745">
                <a:moveTo>
                  <a:pt x="331469" y="0"/>
                </a:moveTo>
                <a:lnTo>
                  <a:pt x="626249" y="0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4949190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5323332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5711952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6090665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6479285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6839711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7228331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7597902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8014716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8384285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8" name="object 158"/>
          <p:cNvSpPr/>
          <p:nvPr/>
        </p:nvSpPr>
        <p:spPr>
          <a:xfrm>
            <a:off x="8753856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9123426" y="1981960"/>
            <a:ext cx="257175" cy="5715"/>
          </a:xfrm>
          <a:custGeom>
            <a:avLst/>
            <a:gdLst/>
            <a:ahLst/>
            <a:cxnLst/>
            <a:rect l="l" t="t" r="r" b="b"/>
            <a:pathLst>
              <a:path w="257175" h="5714">
                <a:moveTo>
                  <a:pt x="-19050" y="2762"/>
                </a:moveTo>
                <a:lnTo>
                  <a:pt x="275729" y="2762"/>
                </a:lnTo>
              </a:path>
            </a:pathLst>
          </a:custGeom>
          <a:ln w="4362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0" name="object 160"/>
          <p:cNvSpPr txBox="1"/>
          <p:nvPr/>
        </p:nvSpPr>
        <p:spPr>
          <a:xfrm>
            <a:off x="3152283" y="1344129"/>
            <a:ext cx="14351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P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61" name="object 161"/>
          <p:cNvSpPr txBox="1"/>
          <p:nvPr/>
        </p:nvSpPr>
        <p:spPr>
          <a:xfrm>
            <a:off x="4267851" y="1344129"/>
            <a:ext cx="34036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WT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62" name="object 162"/>
          <p:cNvSpPr txBox="1"/>
          <p:nvPr/>
        </p:nvSpPr>
        <p:spPr>
          <a:xfrm>
            <a:off x="5269805" y="1344129"/>
            <a:ext cx="26352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Calibri"/>
                <a:cs typeface="Calibri"/>
              </a:rPr>
              <a:t>C1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63" name="object 163"/>
          <p:cNvSpPr txBox="1"/>
          <p:nvPr/>
        </p:nvSpPr>
        <p:spPr>
          <a:xfrm>
            <a:off x="6453496" y="1344129"/>
            <a:ext cx="28575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Calibri"/>
                <a:cs typeface="Calibri"/>
              </a:rPr>
              <a:t>G</a:t>
            </a:r>
            <a:r>
              <a:rPr sz="1800" dirty="0">
                <a:latin typeface="Calibri"/>
                <a:cs typeface="Calibri"/>
              </a:rPr>
              <a:t>2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64" name="object 164"/>
          <p:cNvSpPr txBox="1"/>
          <p:nvPr/>
        </p:nvSpPr>
        <p:spPr>
          <a:xfrm>
            <a:off x="7618213" y="1344129"/>
            <a:ext cx="28384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Calibri"/>
                <a:cs typeface="Calibri"/>
              </a:rPr>
              <a:t>H2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65" name="object 165"/>
          <p:cNvSpPr txBox="1"/>
          <p:nvPr/>
        </p:nvSpPr>
        <p:spPr>
          <a:xfrm>
            <a:off x="8712749" y="1344129"/>
            <a:ext cx="28384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Calibri"/>
                <a:cs typeface="Calibri"/>
              </a:rPr>
              <a:t>H8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66" name="object 166"/>
          <p:cNvSpPr/>
          <p:nvPr/>
        </p:nvSpPr>
        <p:spPr>
          <a:xfrm>
            <a:off x="2689098" y="1680210"/>
            <a:ext cx="988060" cy="142875"/>
          </a:xfrm>
          <a:custGeom>
            <a:avLst/>
            <a:gdLst/>
            <a:ahLst/>
            <a:cxnLst/>
            <a:rect l="l" t="t" r="r" b="b"/>
            <a:pathLst>
              <a:path w="988060" h="142875">
                <a:moveTo>
                  <a:pt x="0" y="142494"/>
                </a:moveTo>
                <a:lnTo>
                  <a:pt x="933" y="87026"/>
                </a:lnTo>
                <a:lnTo>
                  <a:pt x="3479" y="41733"/>
                </a:lnTo>
                <a:lnTo>
                  <a:pt x="7254" y="11197"/>
                </a:lnTo>
                <a:lnTo>
                  <a:pt x="11874" y="0"/>
                </a:lnTo>
                <a:lnTo>
                  <a:pt x="975677" y="0"/>
                </a:lnTo>
                <a:lnTo>
                  <a:pt x="980297" y="11197"/>
                </a:lnTo>
                <a:lnTo>
                  <a:pt x="984072" y="41733"/>
                </a:lnTo>
                <a:lnTo>
                  <a:pt x="986618" y="87026"/>
                </a:lnTo>
                <a:lnTo>
                  <a:pt x="987552" y="142494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7" name="object 167"/>
          <p:cNvSpPr/>
          <p:nvPr/>
        </p:nvSpPr>
        <p:spPr>
          <a:xfrm>
            <a:off x="3882390" y="1707642"/>
            <a:ext cx="988694" cy="142875"/>
          </a:xfrm>
          <a:custGeom>
            <a:avLst/>
            <a:gdLst/>
            <a:ahLst/>
            <a:cxnLst/>
            <a:rect l="l" t="t" r="r" b="b"/>
            <a:pathLst>
              <a:path w="988695" h="142875">
                <a:moveTo>
                  <a:pt x="0" y="142494"/>
                </a:moveTo>
                <a:lnTo>
                  <a:pt x="933" y="87026"/>
                </a:lnTo>
                <a:lnTo>
                  <a:pt x="3479" y="41733"/>
                </a:lnTo>
                <a:lnTo>
                  <a:pt x="7254" y="11197"/>
                </a:lnTo>
                <a:lnTo>
                  <a:pt x="11874" y="0"/>
                </a:lnTo>
                <a:lnTo>
                  <a:pt x="976439" y="0"/>
                </a:lnTo>
                <a:lnTo>
                  <a:pt x="981059" y="11197"/>
                </a:lnTo>
                <a:lnTo>
                  <a:pt x="984834" y="41733"/>
                </a:lnTo>
                <a:lnTo>
                  <a:pt x="987380" y="87026"/>
                </a:lnTo>
                <a:lnTo>
                  <a:pt x="988313" y="142494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8" name="object 168"/>
          <p:cNvSpPr/>
          <p:nvPr/>
        </p:nvSpPr>
        <p:spPr>
          <a:xfrm>
            <a:off x="4980432" y="1707642"/>
            <a:ext cx="988694" cy="142875"/>
          </a:xfrm>
          <a:custGeom>
            <a:avLst/>
            <a:gdLst/>
            <a:ahLst/>
            <a:cxnLst/>
            <a:rect l="l" t="t" r="r" b="b"/>
            <a:pathLst>
              <a:path w="988695" h="142875">
                <a:moveTo>
                  <a:pt x="0" y="142494"/>
                </a:moveTo>
                <a:lnTo>
                  <a:pt x="933" y="87026"/>
                </a:lnTo>
                <a:lnTo>
                  <a:pt x="3479" y="41733"/>
                </a:lnTo>
                <a:lnTo>
                  <a:pt x="7254" y="11197"/>
                </a:lnTo>
                <a:lnTo>
                  <a:pt x="11874" y="0"/>
                </a:lnTo>
                <a:lnTo>
                  <a:pt x="976439" y="0"/>
                </a:lnTo>
                <a:lnTo>
                  <a:pt x="981059" y="11197"/>
                </a:lnTo>
                <a:lnTo>
                  <a:pt x="984834" y="41733"/>
                </a:lnTo>
                <a:lnTo>
                  <a:pt x="987380" y="87026"/>
                </a:lnTo>
                <a:lnTo>
                  <a:pt x="988313" y="142494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9" name="object 169"/>
          <p:cNvSpPr/>
          <p:nvPr/>
        </p:nvSpPr>
        <p:spPr>
          <a:xfrm>
            <a:off x="6079235" y="1707642"/>
            <a:ext cx="988060" cy="142875"/>
          </a:xfrm>
          <a:custGeom>
            <a:avLst/>
            <a:gdLst/>
            <a:ahLst/>
            <a:cxnLst/>
            <a:rect l="l" t="t" r="r" b="b"/>
            <a:pathLst>
              <a:path w="988059" h="142875">
                <a:moveTo>
                  <a:pt x="0" y="142494"/>
                </a:moveTo>
                <a:lnTo>
                  <a:pt x="933" y="87026"/>
                </a:lnTo>
                <a:lnTo>
                  <a:pt x="3479" y="41733"/>
                </a:lnTo>
                <a:lnTo>
                  <a:pt x="7254" y="11197"/>
                </a:lnTo>
                <a:lnTo>
                  <a:pt x="11874" y="0"/>
                </a:lnTo>
                <a:lnTo>
                  <a:pt x="975677" y="0"/>
                </a:lnTo>
                <a:lnTo>
                  <a:pt x="980297" y="11197"/>
                </a:lnTo>
                <a:lnTo>
                  <a:pt x="984072" y="41733"/>
                </a:lnTo>
                <a:lnTo>
                  <a:pt x="986618" y="87026"/>
                </a:lnTo>
                <a:lnTo>
                  <a:pt x="987552" y="142494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0" name="object 170"/>
          <p:cNvSpPr/>
          <p:nvPr/>
        </p:nvSpPr>
        <p:spPr>
          <a:xfrm>
            <a:off x="7240523" y="1707642"/>
            <a:ext cx="988060" cy="142875"/>
          </a:xfrm>
          <a:custGeom>
            <a:avLst/>
            <a:gdLst/>
            <a:ahLst/>
            <a:cxnLst/>
            <a:rect l="l" t="t" r="r" b="b"/>
            <a:pathLst>
              <a:path w="988059" h="142875">
                <a:moveTo>
                  <a:pt x="0" y="142494"/>
                </a:moveTo>
                <a:lnTo>
                  <a:pt x="933" y="87026"/>
                </a:lnTo>
                <a:lnTo>
                  <a:pt x="3479" y="41733"/>
                </a:lnTo>
                <a:lnTo>
                  <a:pt x="7254" y="11197"/>
                </a:lnTo>
                <a:lnTo>
                  <a:pt x="11874" y="0"/>
                </a:lnTo>
                <a:lnTo>
                  <a:pt x="975677" y="0"/>
                </a:lnTo>
                <a:lnTo>
                  <a:pt x="980297" y="11197"/>
                </a:lnTo>
                <a:lnTo>
                  <a:pt x="984072" y="41733"/>
                </a:lnTo>
                <a:lnTo>
                  <a:pt x="986618" y="87026"/>
                </a:lnTo>
                <a:lnTo>
                  <a:pt x="987552" y="142494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1" name="object 171"/>
          <p:cNvSpPr/>
          <p:nvPr/>
        </p:nvSpPr>
        <p:spPr>
          <a:xfrm>
            <a:off x="8414766" y="1721357"/>
            <a:ext cx="988060" cy="142875"/>
          </a:xfrm>
          <a:custGeom>
            <a:avLst/>
            <a:gdLst/>
            <a:ahLst/>
            <a:cxnLst/>
            <a:rect l="l" t="t" r="r" b="b"/>
            <a:pathLst>
              <a:path w="988059" h="142875">
                <a:moveTo>
                  <a:pt x="0" y="142494"/>
                </a:moveTo>
                <a:lnTo>
                  <a:pt x="933" y="87026"/>
                </a:lnTo>
                <a:lnTo>
                  <a:pt x="3479" y="41733"/>
                </a:lnTo>
                <a:lnTo>
                  <a:pt x="7254" y="11197"/>
                </a:lnTo>
                <a:lnTo>
                  <a:pt x="11874" y="0"/>
                </a:lnTo>
                <a:lnTo>
                  <a:pt x="975677" y="0"/>
                </a:lnTo>
                <a:lnTo>
                  <a:pt x="980297" y="11197"/>
                </a:lnTo>
                <a:lnTo>
                  <a:pt x="984072" y="41733"/>
                </a:lnTo>
                <a:lnTo>
                  <a:pt x="986618" y="87026"/>
                </a:lnTo>
                <a:lnTo>
                  <a:pt x="987552" y="142494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9997353" y="1371358"/>
            <a:ext cx="664345" cy="562021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3" name="object 173"/>
          <p:cNvSpPr txBox="1"/>
          <p:nvPr/>
        </p:nvSpPr>
        <p:spPr>
          <a:xfrm>
            <a:off x="9539978" y="1725874"/>
            <a:ext cx="33718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35" dirty="0">
                <a:latin typeface="Calibri"/>
                <a:cs typeface="Calibri"/>
              </a:rPr>
              <a:t>A</a:t>
            </a:r>
            <a:r>
              <a:rPr sz="1800" dirty="0">
                <a:latin typeface="Calibri"/>
                <a:cs typeface="Calibri"/>
              </a:rPr>
              <a:t>vr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74" name="TextBox 89">
            <a:extLst>
              <a:ext uri="{FF2B5EF4-FFF2-40B4-BE49-F238E27FC236}">
                <a16:creationId xmlns:a16="http://schemas.microsoft.com/office/drawing/2014/main" id="{96CB5D5F-F477-4FC8-BA50-0BE372364FAC}"/>
              </a:ext>
            </a:extLst>
          </p:cNvPr>
          <p:cNvSpPr txBox="1"/>
          <p:nvPr/>
        </p:nvSpPr>
        <p:spPr>
          <a:xfrm>
            <a:off x="942922" y="788110"/>
            <a:ext cx="1047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igure.S1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8F346B5D-7D5C-056D-A13F-164A0D04B680}"/>
              </a:ext>
            </a:extLst>
          </p:cNvPr>
          <p:cNvSpPr txBox="1"/>
          <p:nvPr/>
        </p:nvSpPr>
        <p:spPr>
          <a:xfrm>
            <a:off x="616046" y="5784189"/>
            <a:ext cx="10045652" cy="4776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Supplementary Figure 1. MicroRNAs that were upregulated upon IL-11Rα knockdown as measured by microarray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sults are shown as log2 ratio scores. P – parental cells; WT – wild-type cells; C1, G2, H2, and H8 –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RNA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sed for knockdown of IL-11Rα;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vr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– averag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3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varajan,Eswaran</dc:creator>
  <cp:lastModifiedBy>Devarajan,Eswaran</cp:lastModifiedBy>
  <cp:revision>3</cp:revision>
  <dcterms:created xsi:type="dcterms:W3CDTF">2022-11-10T17:06:56Z</dcterms:created>
  <dcterms:modified xsi:type="dcterms:W3CDTF">2024-04-11T15:36:44Z</dcterms:modified>
</cp:coreProperties>
</file>